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92" r:id="rId2"/>
    <p:sldId id="302" r:id="rId3"/>
    <p:sldId id="304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C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921BAF-5D15-421F-8337-927C56B889B3}" v="3" dt="2022-07-26T16:50:12.047"/>
    <p1510:client id="{7B59DA6B-9F3D-4823-A02D-23406493E722}" v="14" dt="2022-06-08T15:40:20.488"/>
    <p1510:client id="{869DEACF-2A53-454C-A82A-B1F733C65CF7}" v="542" dt="2022-06-13T17:50:50.6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07" autoAdjust="0"/>
    <p:restoredTop sz="97530"/>
  </p:normalViewPr>
  <p:slideViewPr>
    <p:cSldViewPr snapToGrid="0" snapToObjects="1">
      <p:cViewPr varScale="1">
        <p:scale>
          <a:sx n="109" d="100"/>
          <a:sy n="109" d="100"/>
        </p:scale>
        <p:origin x="238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rissa Barboza" userId="ikorq0DR5pI78/zrr/iUwtlciP5Hn4XSaPtoyGvjkGw=" providerId="None" clId="Web-{869DEACF-2A53-454C-A82A-B1F733C65CF7}"/>
    <pc:docChg chg="modSld">
      <pc:chgData name="Clarissa Barboza" userId="ikorq0DR5pI78/zrr/iUwtlciP5Hn4XSaPtoyGvjkGw=" providerId="None" clId="Web-{869DEACF-2A53-454C-A82A-B1F733C65CF7}" dt="2022-06-13T15:18:01.825" v="4" actId="20577"/>
      <pc:docMkLst>
        <pc:docMk/>
      </pc:docMkLst>
      <pc:sldChg chg="modSp">
        <pc:chgData name="Clarissa Barboza" userId="ikorq0DR5pI78/zrr/iUwtlciP5Hn4XSaPtoyGvjkGw=" providerId="None" clId="Web-{869DEACF-2A53-454C-A82A-B1F733C65CF7}" dt="2022-06-13T15:18:01.825" v="4" actId="20577"/>
        <pc:sldMkLst>
          <pc:docMk/>
          <pc:sldMk cId="3979070742" sldId="292"/>
        </pc:sldMkLst>
        <pc:spChg chg="mod">
          <ac:chgData name="Clarissa Barboza" userId="ikorq0DR5pI78/zrr/iUwtlciP5Hn4XSaPtoyGvjkGw=" providerId="None" clId="Web-{869DEACF-2A53-454C-A82A-B1F733C65CF7}" dt="2022-06-13T15:18:01.825" v="4" actId="20577"/>
          <ac:spMkLst>
            <pc:docMk/>
            <pc:sldMk cId="3979070742" sldId="292"/>
            <ac:spMk id="5" creationId="{F659D971-4C34-414B-AA72-66245664411B}"/>
          </ac:spMkLst>
        </pc:spChg>
        <pc:picChg chg="mod">
          <ac:chgData name="Clarissa Barboza" userId="ikorq0DR5pI78/zrr/iUwtlciP5Hn4XSaPtoyGvjkGw=" providerId="None" clId="Web-{869DEACF-2A53-454C-A82A-B1F733C65CF7}" dt="2022-06-13T15:17:26.574" v="1" actId="14100"/>
          <ac:picMkLst>
            <pc:docMk/>
            <pc:sldMk cId="3979070742" sldId="292"/>
            <ac:picMk id="4" creationId="{17F63D33-1D15-C245-9407-9F7890482EA3}"/>
          </ac:picMkLst>
        </pc:picChg>
      </pc:sldChg>
    </pc:docChg>
  </pc:docChgLst>
  <pc:docChgLst>
    <pc:chgData name="Clarissa Barboza" userId="ikorq0DR5pI78/zrr/iUwtlciP5Hn4XSaPtoyGvjkGw=" providerId="None" clId="Web-{7B59DA6B-9F3D-4823-A02D-23406493E722}"/>
    <pc:docChg chg="delSld modSld">
      <pc:chgData name="Clarissa Barboza" userId="ikorq0DR5pI78/zrr/iUwtlciP5Hn4XSaPtoyGvjkGw=" providerId="None" clId="Web-{7B59DA6B-9F3D-4823-A02D-23406493E722}" dt="2022-06-08T15:40:18.816" v="6" actId="20577"/>
      <pc:docMkLst>
        <pc:docMk/>
      </pc:docMkLst>
      <pc:sldChg chg="modSp">
        <pc:chgData name="Clarissa Barboza" userId="ikorq0DR5pI78/zrr/iUwtlciP5Hn4XSaPtoyGvjkGw=" providerId="None" clId="Web-{7B59DA6B-9F3D-4823-A02D-23406493E722}" dt="2022-06-08T15:40:18.816" v="6" actId="20577"/>
        <pc:sldMkLst>
          <pc:docMk/>
          <pc:sldMk cId="359972961" sldId="285"/>
        </pc:sldMkLst>
        <pc:spChg chg="mod">
          <ac:chgData name="Clarissa Barboza" userId="ikorq0DR5pI78/zrr/iUwtlciP5Hn4XSaPtoyGvjkGw=" providerId="None" clId="Web-{7B59DA6B-9F3D-4823-A02D-23406493E722}" dt="2022-06-08T15:40:18.816" v="6" actId="20577"/>
          <ac:spMkLst>
            <pc:docMk/>
            <pc:sldMk cId="359972961" sldId="285"/>
            <ac:spMk id="22" creationId="{2C70EFC3-18CE-2848-83DF-BBC508F42D7D}"/>
          </ac:spMkLst>
        </pc:spChg>
      </pc:sldChg>
      <pc:sldChg chg="modSp">
        <pc:chgData name="Clarissa Barboza" userId="ikorq0DR5pI78/zrr/iUwtlciP5Hn4XSaPtoyGvjkGw=" providerId="None" clId="Web-{7B59DA6B-9F3D-4823-A02D-23406493E722}" dt="2022-06-08T15:40:16.238" v="5" actId="20577"/>
        <pc:sldMkLst>
          <pc:docMk/>
          <pc:sldMk cId="3108340004" sldId="286"/>
        </pc:sldMkLst>
        <pc:spChg chg="mod">
          <ac:chgData name="Clarissa Barboza" userId="ikorq0DR5pI78/zrr/iUwtlciP5Hn4XSaPtoyGvjkGw=" providerId="None" clId="Web-{7B59DA6B-9F3D-4823-A02D-23406493E722}" dt="2022-06-08T15:40:16.238" v="5" actId="20577"/>
          <ac:spMkLst>
            <pc:docMk/>
            <pc:sldMk cId="3108340004" sldId="286"/>
            <ac:spMk id="18" creationId="{DDB58875-73E3-DA40-ABDF-15F7BDECD93D}"/>
          </ac:spMkLst>
        </pc:spChg>
      </pc:sldChg>
      <pc:sldChg chg="modSp">
        <pc:chgData name="Clarissa Barboza" userId="ikorq0DR5pI78/zrr/iUwtlciP5Hn4XSaPtoyGvjkGw=" providerId="None" clId="Web-{7B59DA6B-9F3D-4823-A02D-23406493E722}" dt="2022-06-08T15:40:10.675" v="4" actId="20577"/>
        <pc:sldMkLst>
          <pc:docMk/>
          <pc:sldMk cId="1540120508" sldId="293"/>
        </pc:sldMkLst>
        <pc:spChg chg="mod">
          <ac:chgData name="Clarissa Barboza" userId="ikorq0DR5pI78/zrr/iUwtlciP5Hn4XSaPtoyGvjkGw=" providerId="None" clId="Web-{7B59DA6B-9F3D-4823-A02D-23406493E722}" dt="2022-06-08T15:40:10.675" v="4" actId="20577"/>
          <ac:spMkLst>
            <pc:docMk/>
            <pc:sldMk cId="1540120508" sldId="293"/>
            <ac:spMk id="17" creationId="{F641EC88-CA1F-3242-8A48-BD88AA604A73}"/>
          </ac:spMkLst>
        </pc:spChg>
      </pc:sldChg>
      <pc:sldChg chg="del">
        <pc:chgData name="Clarissa Barboza" userId="ikorq0DR5pI78/zrr/iUwtlciP5Hn4XSaPtoyGvjkGw=" providerId="None" clId="Web-{7B59DA6B-9F3D-4823-A02D-23406493E722}" dt="2022-06-08T15:39:50.424" v="0"/>
        <pc:sldMkLst>
          <pc:docMk/>
          <pc:sldMk cId="3876237593" sldId="298"/>
        </pc:sldMkLst>
      </pc:sldChg>
    </pc:docChg>
  </pc:docChgLst>
  <pc:docChgLst>
    <pc:chgData name="Clarissa Barboza" clId="Web-{869DEACF-2A53-454C-A82A-B1F733C65CF7}"/>
    <pc:docChg chg="addSld delSld modSld">
      <pc:chgData name="Clarissa Barboza" userId="" providerId="" clId="Web-{869DEACF-2A53-454C-A82A-B1F733C65CF7}" dt="2022-06-13T17:50:50.658" v="330" actId="20577"/>
      <pc:docMkLst>
        <pc:docMk/>
      </pc:docMkLst>
      <pc:sldChg chg="addSp delSp modSp">
        <pc:chgData name="Clarissa Barboza" userId="" providerId="" clId="Web-{869DEACF-2A53-454C-A82A-B1F733C65CF7}" dt="2022-06-13T16:41:56.331" v="262" actId="1076"/>
        <pc:sldMkLst>
          <pc:docMk/>
          <pc:sldMk cId="3979070742" sldId="292"/>
        </pc:sldMkLst>
        <pc:spChg chg="del">
          <ac:chgData name="Clarissa Barboza" userId="" providerId="" clId="Web-{869DEACF-2A53-454C-A82A-B1F733C65CF7}" dt="2022-06-13T16:41:47.033" v="260"/>
          <ac:spMkLst>
            <pc:docMk/>
            <pc:sldMk cId="3979070742" sldId="292"/>
            <ac:spMk id="3" creationId="{624688A4-9D9D-224F-9923-483F3840DA7E}"/>
          </ac:spMkLst>
        </pc:spChg>
        <pc:spChg chg="mod">
          <ac:chgData name="Clarissa Barboza" userId="" providerId="" clId="Web-{869DEACF-2A53-454C-A82A-B1F733C65CF7}" dt="2022-06-13T16:41:56.331" v="262" actId="1076"/>
          <ac:spMkLst>
            <pc:docMk/>
            <pc:sldMk cId="3979070742" sldId="292"/>
            <ac:spMk id="5" creationId="{F659D971-4C34-414B-AA72-66245664411B}"/>
          </ac:spMkLst>
        </pc:spChg>
        <pc:spChg chg="add del mod">
          <ac:chgData name="Clarissa Barboza" userId="" providerId="" clId="Web-{869DEACF-2A53-454C-A82A-B1F733C65CF7}" dt="2022-06-13T16:41:51.377" v="261"/>
          <ac:spMkLst>
            <pc:docMk/>
            <pc:sldMk cId="3979070742" sldId="292"/>
            <ac:spMk id="6" creationId="{EA3636D1-0A3E-5C7D-DA1B-CC0DB46339B1}"/>
          </ac:spMkLst>
        </pc:spChg>
        <pc:picChg chg="mod modCrop">
          <ac:chgData name="Clarissa Barboza" userId="" providerId="" clId="Web-{869DEACF-2A53-454C-A82A-B1F733C65CF7}" dt="2022-06-13T16:32:52.580" v="242"/>
          <ac:picMkLst>
            <pc:docMk/>
            <pc:sldMk cId="3979070742" sldId="292"/>
            <ac:picMk id="4" creationId="{17F63D33-1D15-C245-9407-9F7890482EA3}"/>
          </ac:picMkLst>
        </pc:picChg>
      </pc:sldChg>
      <pc:sldChg chg="addSp delSp modSp">
        <pc:chgData name="Clarissa Barboza" userId="" providerId="" clId="Web-{869DEACF-2A53-454C-A82A-B1F733C65CF7}" dt="2022-06-13T16:23:38.812" v="45" actId="14100"/>
        <pc:sldMkLst>
          <pc:docMk/>
          <pc:sldMk cId="1540120508" sldId="293"/>
        </pc:sldMkLst>
        <pc:picChg chg="add mod">
          <ac:chgData name="Clarissa Barboza" userId="" providerId="" clId="Web-{869DEACF-2A53-454C-A82A-B1F733C65CF7}" dt="2022-06-13T16:23:38.812" v="45" actId="14100"/>
          <ac:picMkLst>
            <pc:docMk/>
            <pc:sldMk cId="1540120508" sldId="293"/>
            <ac:picMk id="2" creationId="{EB43066D-23D0-2FCC-4FE1-BDF35F84BB9E}"/>
          </ac:picMkLst>
        </pc:picChg>
        <pc:picChg chg="del mod">
          <ac:chgData name="Clarissa Barboza" userId="" providerId="" clId="Web-{869DEACF-2A53-454C-A82A-B1F733C65CF7}" dt="2022-06-13T16:23:29.640" v="42"/>
          <ac:picMkLst>
            <pc:docMk/>
            <pc:sldMk cId="1540120508" sldId="293"/>
            <ac:picMk id="32" creationId="{839FF263-0AF0-3C40-AA62-AF3A8AAB001E}"/>
          </ac:picMkLst>
        </pc:picChg>
      </pc:sldChg>
      <pc:sldChg chg="del">
        <pc:chgData name="Clarissa Barboza" userId="" providerId="" clId="Web-{869DEACF-2A53-454C-A82A-B1F733C65CF7}" dt="2022-06-13T16:32:18.578" v="239"/>
        <pc:sldMkLst>
          <pc:docMk/>
          <pc:sldMk cId="1517409109" sldId="296"/>
        </pc:sldMkLst>
      </pc:sldChg>
      <pc:sldChg chg="del">
        <pc:chgData name="Clarissa Barboza" userId="" providerId="" clId="Web-{869DEACF-2A53-454C-A82A-B1F733C65CF7}" dt="2022-06-13T16:32:19.062" v="240"/>
        <pc:sldMkLst>
          <pc:docMk/>
          <pc:sldMk cId="3019861858" sldId="299"/>
        </pc:sldMkLst>
      </pc:sldChg>
      <pc:sldChg chg="del">
        <pc:chgData name="Clarissa Barboza" userId="" providerId="" clId="Web-{869DEACF-2A53-454C-A82A-B1F733C65CF7}" dt="2022-06-13T16:32:14.015" v="238"/>
        <pc:sldMkLst>
          <pc:docMk/>
          <pc:sldMk cId="3135841636" sldId="300"/>
        </pc:sldMkLst>
      </pc:sldChg>
      <pc:sldChg chg="del">
        <pc:chgData name="Clarissa Barboza" userId="" providerId="" clId="Web-{869DEACF-2A53-454C-A82A-B1F733C65CF7}" dt="2022-06-13T16:32:09.765" v="236"/>
        <pc:sldMkLst>
          <pc:docMk/>
          <pc:sldMk cId="1825701226" sldId="301"/>
        </pc:sldMkLst>
      </pc:sldChg>
      <pc:sldChg chg="delSp modSp">
        <pc:chgData name="Clarissa Barboza" userId="" providerId="" clId="Web-{869DEACF-2A53-454C-A82A-B1F733C65CF7}" dt="2022-06-13T16:42:04.941" v="264" actId="1076"/>
        <pc:sldMkLst>
          <pc:docMk/>
          <pc:sldMk cId="1957857969" sldId="302"/>
        </pc:sldMkLst>
        <pc:spChg chg="mod">
          <ac:chgData name="Clarissa Barboza" userId="" providerId="" clId="Web-{869DEACF-2A53-454C-A82A-B1F733C65CF7}" dt="2022-06-13T16:42:04.941" v="264" actId="1076"/>
          <ac:spMkLst>
            <pc:docMk/>
            <pc:sldMk cId="1957857969" sldId="302"/>
            <ac:spMk id="4" creationId="{886B267F-0FB9-C948-862C-7D96B60C3403}"/>
          </ac:spMkLst>
        </pc:spChg>
        <pc:spChg chg="del">
          <ac:chgData name="Clarissa Barboza" userId="" providerId="" clId="Web-{869DEACF-2A53-454C-A82A-B1F733C65CF7}" dt="2022-06-13T16:42:01.097" v="263"/>
          <ac:spMkLst>
            <pc:docMk/>
            <pc:sldMk cId="1957857969" sldId="302"/>
            <ac:spMk id="6" creationId="{570A6DA1-96AB-F24F-B0EA-F0BB0A659132}"/>
          </ac:spMkLst>
        </pc:spChg>
      </pc:sldChg>
      <pc:sldChg chg="new del">
        <pc:chgData name="Clarissa Barboza" userId="" providerId="" clId="Web-{869DEACF-2A53-454C-A82A-B1F733C65CF7}" dt="2022-06-13T16:40:22.372" v="245"/>
        <pc:sldMkLst>
          <pc:docMk/>
          <pc:sldMk cId="1393730664" sldId="303"/>
        </pc:sldMkLst>
      </pc:sldChg>
      <pc:sldChg chg="del">
        <pc:chgData name="Clarissa Barboza" userId="" providerId="" clId="Web-{869DEACF-2A53-454C-A82A-B1F733C65CF7}" dt="2022-06-13T16:32:11.483" v="237"/>
        <pc:sldMkLst>
          <pc:docMk/>
          <pc:sldMk cId="1719075849" sldId="303"/>
        </pc:sldMkLst>
      </pc:sldChg>
      <pc:sldChg chg="addSp delSp modSp add">
        <pc:chgData name="Clarissa Barboza" userId="" providerId="" clId="Web-{869DEACF-2A53-454C-A82A-B1F733C65CF7}" dt="2022-06-13T17:50:50.658" v="330" actId="20577"/>
        <pc:sldMkLst>
          <pc:docMk/>
          <pc:sldMk cId="318103903" sldId="304"/>
        </pc:sldMkLst>
        <pc:spChg chg="add del mod">
          <ac:chgData name="Clarissa Barboza" userId="" providerId="" clId="Web-{869DEACF-2A53-454C-A82A-B1F733C65CF7}" dt="2022-06-13T17:45:54.390" v="266"/>
          <ac:spMkLst>
            <pc:docMk/>
            <pc:sldMk cId="318103903" sldId="304"/>
            <ac:spMk id="3" creationId="{56FA399C-84FF-C111-19B5-FAD1CC4AAF4F}"/>
          </ac:spMkLst>
        </pc:spChg>
        <pc:spChg chg="mod">
          <ac:chgData name="Clarissa Barboza" userId="" providerId="" clId="Web-{869DEACF-2A53-454C-A82A-B1F733C65CF7}" dt="2022-06-13T17:50:50.658" v="330" actId="20577"/>
          <ac:spMkLst>
            <pc:docMk/>
            <pc:sldMk cId="318103903" sldId="304"/>
            <ac:spMk id="4" creationId="{4DD52F94-66FA-4A49-803C-6595173E8B90}"/>
          </ac:spMkLst>
        </pc:spChg>
        <pc:spChg chg="del">
          <ac:chgData name="Clarissa Barboza" userId="" providerId="" clId="Web-{869DEACF-2A53-454C-A82A-B1F733C65CF7}" dt="2022-06-13T16:40:41.232" v="247"/>
          <ac:spMkLst>
            <pc:docMk/>
            <pc:sldMk cId="318103903" sldId="304"/>
            <ac:spMk id="7" creationId="{40EF1375-925A-444E-A51D-411ADA520EE8}"/>
          </ac:spMkLst>
        </pc:spChg>
        <pc:picChg chg="add mod ord">
          <ac:chgData name="Clarissa Barboza" userId="" providerId="" clId="Web-{869DEACF-2A53-454C-A82A-B1F733C65CF7}" dt="2022-06-13T17:46:00.125" v="268" actId="14100"/>
          <ac:picMkLst>
            <pc:docMk/>
            <pc:sldMk cId="318103903" sldId="304"/>
            <ac:picMk id="5" creationId="{A7641396-32F6-D616-0234-7CF83329DF51}"/>
          </ac:picMkLst>
        </pc:picChg>
        <pc:picChg chg="del mod">
          <ac:chgData name="Clarissa Barboza" userId="" providerId="" clId="Web-{869DEACF-2A53-454C-A82A-B1F733C65CF7}" dt="2022-06-13T17:45:53.827" v="265"/>
          <ac:picMkLst>
            <pc:docMk/>
            <pc:sldMk cId="318103903" sldId="304"/>
            <ac:picMk id="6" creationId="{728C16A8-CB3C-6741-9379-F057E2786010}"/>
          </ac:picMkLst>
        </pc:picChg>
      </pc:sldChg>
    </pc:docChg>
  </pc:docChgLst>
  <pc:docChgLst>
    <pc:chgData name="Clarissa Barboza" userId="ikorq0DR5pI78/zrr/iUwtlciP5Hn4XSaPtoyGvjkGw=" providerId="None" clId="Web-{51921BAF-5D15-421F-8337-927C56B889B3}"/>
    <pc:docChg chg="modSld">
      <pc:chgData name="Clarissa Barboza" userId="ikorq0DR5pI78/zrr/iUwtlciP5Hn4XSaPtoyGvjkGw=" providerId="None" clId="Web-{51921BAF-5D15-421F-8337-927C56B889B3}" dt="2022-07-26T16:50:12.047" v="2" actId="1076"/>
      <pc:docMkLst>
        <pc:docMk/>
      </pc:docMkLst>
      <pc:sldChg chg="addSp delSp modSp">
        <pc:chgData name="Clarissa Barboza" userId="ikorq0DR5pI78/zrr/iUwtlciP5Hn4XSaPtoyGvjkGw=" providerId="None" clId="Web-{51921BAF-5D15-421F-8337-927C56B889B3}" dt="2022-07-26T16:50:12.047" v="2" actId="1076"/>
        <pc:sldMkLst>
          <pc:docMk/>
          <pc:sldMk cId="318103903" sldId="304"/>
        </pc:sldMkLst>
        <pc:spChg chg="add del mod">
          <ac:chgData name="Clarissa Barboza" userId="ikorq0DR5pI78/zrr/iUwtlciP5Hn4XSaPtoyGvjkGw=" providerId="None" clId="Web-{51921BAF-5D15-421F-8337-927C56B889B3}" dt="2022-07-26T16:50:10.001" v="1"/>
          <ac:spMkLst>
            <pc:docMk/>
            <pc:sldMk cId="318103903" sldId="304"/>
            <ac:spMk id="3" creationId="{9F7DC62C-D8FF-3145-950B-6C55598C24B3}"/>
          </ac:spMkLst>
        </pc:spChg>
        <pc:picChg chg="del">
          <ac:chgData name="Clarissa Barboza" userId="ikorq0DR5pI78/zrr/iUwtlciP5Hn4XSaPtoyGvjkGw=" providerId="None" clId="Web-{51921BAF-5D15-421F-8337-927C56B889B3}" dt="2022-07-26T16:50:09.047" v="0"/>
          <ac:picMkLst>
            <pc:docMk/>
            <pc:sldMk cId="318103903" sldId="304"/>
            <ac:picMk id="5" creationId="{A7641396-32F6-D616-0234-7CF83329DF51}"/>
          </ac:picMkLst>
        </pc:picChg>
        <pc:picChg chg="add mod ord">
          <ac:chgData name="Clarissa Barboza" userId="ikorq0DR5pI78/zrr/iUwtlciP5Hn4XSaPtoyGvjkGw=" providerId="None" clId="Web-{51921BAF-5D15-421F-8337-927C56B889B3}" dt="2022-07-26T16:50:12.047" v="2" actId="1076"/>
          <ac:picMkLst>
            <pc:docMk/>
            <pc:sldMk cId="318103903" sldId="304"/>
            <ac:picMk id="6" creationId="{AD528DC9-65E6-E2E2-FAC7-7D5A70BD8F5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1B9885-E442-AD42-9340-A49B487C19CD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B00EE1-F282-F94B-B738-F1CAF510A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38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530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69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026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434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093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06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231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18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054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013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044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6A9FB-27F8-9A44-9A1B-2E695180B82F}" type="datetimeFigureOut">
              <a:rPr lang="en-US" smtClean="0"/>
              <a:t>11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7C198-F7A0-3442-BEE9-46AE3B74ED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7F63D33-1D15-C245-9407-9F7890482E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833" t="11899" r="-59" b="253"/>
          <a:stretch/>
        </p:blipFill>
        <p:spPr>
          <a:xfrm>
            <a:off x="371047" y="824455"/>
            <a:ext cx="3064011" cy="295775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659D971-4C34-414B-AA72-66245664411B}"/>
              </a:ext>
            </a:extLst>
          </p:cNvPr>
          <p:cNvSpPr txBox="1"/>
          <p:nvPr/>
        </p:nvSpPr>
        <p:spPr>
          <a:xfrm>
            <a:off x="283464" y="7640640"/>
            <a:ext cx="6053328" cy="138499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Insulin responses are decreased in adipocytes treated with increasing doses of LUM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lucose uptake assay in human VAT adipocytes from NDM subjects treated with distinct doses of human </a:t>
            </a:r>
            <a:r>
              <a:rPr lang="en-US" sz="140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recombina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UM for 24h in serum free DMEM/F12 50:50 medium at 37C. Axis 'x' demonstrates fold change glucose uptake of adipocytes treated with insulin over non-treated adipocytes. </a:t>
            </a:r>
          </a:p>
        </p:txBody>
      </p:sp>
    </p:spTree>
    <p:extLst>
      <p:ext uri="{BB962C8B-B14F-4D97-AF65-F5344CB8AC3E}">
        <p14:creationId xmlns:p14="http://schemas.microsoft.com/office/powerpoint/2010/main" val="3979070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6B267F-0FB9-C948-862C-7D96B60C3403}"/>
              </a:ext>
            </a:extLst>
          </p:cNvPr>
          <p:cNvSpPr txBox="1"/>
          <p:nvPr/>
        </p:nvSpPr>
        <p:spPr>
          <a:xfrm>
            <a:off x="223755" y="7265327"/>
            <a:ext cx="6053328" cy="181588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LU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ene expression during VAT preadipocyte proliferativ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hase in vitro. Preadipocytes were obtained from VAT of human subjects with obesity through collagenase digestion and plated </a:t>
            </a:r>
            <a:r>
              <a:rPr lang="en-US" sz="140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in DMEM/F12 50:50 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r proliferation. Cells were collected in distinct days </a:t>
            </a:r>
            <a:r>
              <a:rPr lang="en-US" sz="140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(3 wells of a 24-well plate per subject) and flash frozen for subsequent qPCR analysis using TaqMan gene expression </a:t>
            </a:r>
            <a:r>
              <a:rPr lang="en-US" sz="1400" i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LUM</a:t>
            </a:r>
            <a:r>
              <a:rPr lang="en-US" sz="140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assay. B2M was used as housekeeping gene and did not vary between days. Results are demonstrated as fold change over day 3 of proliferation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30C3576-4BFA-094E-9186-DBD70464CA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630" y="1443776"/>
            <a:ext cx="1920755" cy="2053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7857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60A2360-8F45-449A-0ED8-EF2E8622FD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3765170"/>
              </p:ext>
            </p:extLst>
          </p:nvPr>
        </p:nvGraphicFramePr>
        <p:xfrm>
          <a:off x="-45227" y="3902443"/>
          <a:ext cx="6948454" cy="40940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8618408" imgH="4939873" progId="Prism9.Document">
                  <p:embed/>
                </p:oleObj>
              </mc:Choice>
              <mc:Fallback>
                <p:oleObj name="Prism 9" r:id="rId2" imgW="8618408" imgH="493987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45227" y="3902443"/>
                        <a:ext cx="6948454" cy="40940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4DD52F94-66FA-4A49-803C-6595173E8B90}"/>
              </a:ext>
            </a:extLst>
          </p:cNvPr>
          <p:cNvSpPr txBox="1">
            <a:spLocks/>
          </p:cNvSpPr>
          <p:nvPr/>
        </p:nvSpPr>
        <p:spPr>
          <a:xfrm>
            <a:off x="155705" y="7713110"/>
            <a:ext cx="6581730" cy="547581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PCR analysis of adipocytes differentiate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treated with (LUM) or without (CON) human recombinan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umic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24h at the end of differentiation. Data demonstrate fold changes of LUM-treated adipocytes relative to untreated CON arm cells as referent =1. 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PCR analysis of adipocytes differentiate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whic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umic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as knocked down with siRNA (LUM KD) or transfected with scramble RNA (CON) on d7 of differentiation. Data demonstrate fold changes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umic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knockdown adipocytes relative to CON arm (scramble RNA) cells as referent =1. Statistical analyses were performed o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dC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values using paired t-tests within DM or NDM groups comparing experimental  to control groups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050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sidered significant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0.150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n in graphs for clarity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6C24E8F-9066-D342-AF4D-10CB89B5192D}"/>
              </a:ext>
            </a:extLst>
          </p:cNvPr>
          <p:cNvSpPr txBox="1"/>
          <p:nvPr/>
        </p:nvSpPr>
        <p:spPr>
          <a:xfrm>
            <a:off x="0" y="54291"/>
            <a:ext cx="399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. Transcriptional responses to recombinant </a:t>
            </a:r>
            <a:r>
              <a:rPr lang="en-US" sz="1400" dirty="0" err="1"/>
              <a:t>lumican</a:t>
            </a:r>
            <a:endParaRPr lang="en-US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B8AA3E-5E4B-7D95-1183-FACECBFF0EB1}"/>
              </a:ext>
            </a:extLst>
          </p:cNvPr>
          <p:cNvSpPr txBox="1"/>
          <p:nvPr/>
        </p:nvSpPr>
        <p:spPr>
          <a:xfrm>
            <a:off x="44948" y="3830963"/>
            <a:ext cx="3904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. Transcriptional responses to </a:t>
            </a:r>
            <a:r>
              <a:rPr lang="en-US" sz="1400" dirty="0" err="1"/>
              <a:t>lumican</a:t>
            </a:r>
            <a:r>
              <a:rPr lang="en-US" sz="1400" dirty="0"/>
              <a:t> knockdown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CA44CB6-8BC1-E331-1797-C1C903F20A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948734"/>
              </p:ext>
            </p:extLst>
          </p:nvPr>
        </p:nvGraphicFramePr>
        <p:xfrm>
          <a:off x="-45227" y="155441"/>
          <a:ext cx="6948454" cy="39832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8618408" imgH="4939873" progId="Prism9.Document">
                  <p:embed/>
                </p:oleObj>
              </mc:Choice>
              <mc:Fallback>
                <p:oleObj name="Prism 9" r:id="rId4" imgW="8618408" imgH="493987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45227" y="155441"/>
                        <a:ext cx="6948454" cy="39832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7E56116-378C-1D3D-71B0-3C7C022BA2D6}"/>
              </a:ext>
            </a:extLst>
          </p:cNvPr>
          <p:cNvSpPr txBox="1"/>
          <p:nvPr/>
        </p:nvSpPr>
        <p:spPr>
          <a:xfrm>
            <a:off x="3204307" y="2507992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u="sng" dirty="0"/>
              <a:t>P=0.06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81F630-8DA8-30FD-4752-27990EDF1C6D}"/>
              </a:ext>
            </a:extLst>
          </p:cNvPr>
          <p:cNvSpPr txBox="1"/>
          <p:nvPr/>
        </p:nvSpPr>
        <p:spPr>
          <a:xfrm>
            <a:off x="4927599" y="2292548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u="sng" dirty="0"/>
              <a:t>P=0.11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10CA72-0B1B-5BFE-B672-BA7EEDD40831}"/>
              </a:ext>
            </a:extLst>
          </p:cNvPr>
          <p:cNvSpPr txBox="1"/>
          <p:nvPr/>
        </p:nvSpPr>
        <p:spPr>
          <a:xfrm>
            <a:off x="3464154" y="4203612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u="sng" dirty="0"/>
              <a:t>P=0.05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AFA561-8928-C7D5-FC1E-89890D4D00E6}"/>
              </a:ext>
            </a:extLst>
          </p:cNvPr>
          <p:cNvSpPr txBox="1"/>
          <p:nvPr/>
        </p:nvSpPr>
        <p:spPr>
          <a:xfrm>
            <a:off x="4765415" y="4311334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u="sng" dirty="0"/>
              <a:t>P=0.06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1303B9E-42C4-E0C8-B60E-2BD7226E148A}"/>
              </a:ext>
            </a:extLst>
          </p:cNvPr>
          <p:cNvSpPr txBox="1"/>
          <p:nvPr/>
        </p:nvSpPr>
        <p:spPr>
          <a:xfrm>
            <a:off x="4927599" y="6089883"/>
            <a:ext cx="5196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 u="sng" dirty="0"/>
              <a:t>P=0.091</a:t>
            </a:r>
          </a:p>
        </p:txBody>
      </p:sp>
    </p:spTree>
    <p:extLst>
      <p:ext uri="{BB962C8B-B14F-4D97-AF65-F5344CB8AC3E}">
        <p14:creationId xmlns:p14="http://schemas.microsoft.com/office/powerpoint/2010/main" val="318103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129</TotalTime>
  <Words>333</Words>
  <Application>Microsoft Office PowerPoint</Application>
  <PresentationFormat>On-screen Show (4:3)</PresentationFormat>
  <Paragraphs>10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scar javier benitez rojas</dc:creator>
  <cp:lastModifiedBy>O'Rourke, Robert</cp:lastModifiedBy>
  <cp:revision>458</cp:revision>
  <dcterms:created xsi:type="dcterms:W3CDTF">2020-04-13T13:18:05Z</dcterms:created>
  <dcterms:modified xsi:type="dcterms:W3CDTF">2022-11-12T19:31:26Z</dcterms:modified>
</cp:coreProperties>
</file>